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60" y="1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26ABD4-FDFC-4A02-A4B2-07A5F9D2C0DF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C2A68E-E959-4B03-BE3A-72C1A312D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742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C2A68E-E959-4B03-BE3A-72C1A312DAE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61986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B8E26F-A917-792D-25CA-740ED6510C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2EC9649-84E6-6626-8058-50828FF6B2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F7E361-454C-38D6-C752-247936AA5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E750B4-B128-2CDC-F3FA-10F936E17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F5137B-3C31-144F-6EE6-483D477EB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4819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AD2B8F-9A5B-303D-37A3-AD0133B53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C8CBC0-0B2D-12B8-F92D-3B5A5FE2CA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D3B0C7-84DD-5772-FD43-5A3689F03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B7928D-DD95-C00C-BD5D-75D878B8F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7FF318-7B67-7DB7-9B7D-F3F731EC6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155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0B5F260-DA0F-7460-3533-6FA9BFAD1D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FA0620-DB34-E7B8-9038-2A06F9B995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122E02-FC14-DCE6-FC3F-51F9A2209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766040-4472-8A29-CF32-BF1998D38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6CDD7A-84EA-73E1-1D68-96B8685C5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63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9AB07C-1F03-3B32-4D81-B91AF08F4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23B66A-8DED-BF91-68A8-E4ACF4DDA6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475C4E-4A3A-3080-C22A-563D857F1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C9F229-3BBC-F032-8BD3-13BCCE7BC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A09D28-B7BB-1D57-8E53-6DBEFDD12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4721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7C990C-5F69-F336-1529-BF6C58974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BE378A-471C-BFFA-4BA6-0D91FD3C06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1A006B-76CC-FAE6-C6D8-5A6A10C00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22BCEA-C5A1-6314-B437-9DEEAA377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FBCB32-63F6-2245-C2BC-04EA7DEA0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6062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B40A56-1516-51E8-9A0E-CC7ABCD13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8C18CC-0FEE-2310-0F7A-02A3663DA0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6AA1D3-B0FC-E583-C4DD-C061BD8294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6DD46E-B73B-CE9C-685C-BDA612C2A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D8E1B5-3D9D-240E-AD15-5B7F373E4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A208EE-603B-2562-E59D-89D99B746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3971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EFF8D3-E9FB-1827-F284-B3E75C09B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34A6298-26B0-521C-D160-0527B895D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54CE34-E81F-F325-0DE6-243A4D5191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CA5C51C-8AC6-FCE5-8C50-2CAB5B8C73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DCE1709-D888-FB13-2F4E-BCFAB3ECA9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FDCC9C9-903F-4596-127A-ECD161621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9EE88A-6F43-C4A6-6D14-F59BBE198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AB907F5-82BF-6ABA-1A75-703B1CFE7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663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6B9C70-C1C9-804F-5C86-E9B7FF8F0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0B5F07F-093E-6B49-6872-2CEAADDE6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EBE37AB-0637-330A-9AF2-A2881F7FD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69BF62-CA7D-3E8F-D887-D4959BAEB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00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68BE820-C170-02BC-3CBA-CD358E7A5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CA9BC52-BA7F-C673-05F7-9AC9E0167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1F3B489-9F63-65B5-826E-658473CEF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0948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016DEA-4165-62FE-789F-46889A08C3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0341F4-9305-CD82-8440-140B50CA48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77AF0-5413-D7F7-9094-EA9878CDCE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EAF7C7-6648-DCB6-B3C4-8336D66DC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5F7210-ED1B-8B3A-39C2-822416AC7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318BFF-5BE4-184C-29F1-67C23F4E8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7901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8FC42A-2249-B38C-DEC8-89997E8EDA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8CFB3C6-DDA4-41BF-18DA-A5275D1C30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15D01DE-73BC-0E97-CDFD-4764D254ED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800760-977F-6F98-AE6D-9DDA3B258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7AA7AD-5C5D-43AD-C549-D6DC554CA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03238D-B670-0210-7468-E8B17DC77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172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82F8738-E4AF-EBAA-2BF4-519E5A8B8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50847B-D34B-B96B-7642-FB6ABCBD4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8D5707-258D-1098-EFE7-4F06585897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0022C-6E07-4D70-AC92-C561EEFB318B}" type="datetimeFigureOut">
              <a:rPr lang="zh-CN" altLang="en-US" smtClean="0"/>
              <a:t>2024/9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742EC8-12E0-CA03-3F10-F16C75F1F5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D002F5-CB40-DFA7-0ADC-3B1EAB2E60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1292A-FC28-47E1-B0B9-D45CF6C8A5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595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FA40902-9F60-E41F-6FF6-E4378E3C9F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306" y="-171"/>
            <a:ext cx="3247465" cy="202966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4E2DA70-AA9E-5D49-3050-895DC7B21F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970" y="-171"/>
            <a:ext cx="3147428" cy="196714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A14FBDF-CB98-9E5E-5D08-9745E10BDE6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4679" y="-171"/>
            <a:ext cx="3379302" cy="194525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5CDF1C5-ED57-9D28-1716-D2A2F80CDF1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772" y="2111893"/>
            <a:ext cx="3283999" cy="205249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67E77FC4-45E5-13C0-A973-DB19C695E0A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970" y="2111893"/>
            <a:ext cx="3147428" cy="196714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9C9CD510-77B3-C235-F6D8-F95ED258B1A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8145" y="2176060"/>
            <a:ext cx="3506749" cy="201846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74C4B041-26E4-942E-B232-12A33B8FFE2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306" y="4221650"/>
            <a:ext cx="3105927" cy="194120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A08F7D83-E10D-B75C-AD7A-FE0D1738C79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970" y="4221651"/>
            <a:ext cx="3105927" cy="193348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7A844089-90AA-3349-A763-15F6A985E3B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8145" y="4164392"/>
            <a:ext cx="3574618" cy="201846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4878E19E-8869-5282-B270-41F8EF52C1DC}"/>
              </a:ext>
            </a:extLst>
          </p:cNvPr>
          <p:cNvSpPr txBox="1"/>
          <p:nvPr/>
        </p:nvSpPr>
        <p:spPr>
          <a:xfrm>
            <a:off x="400211" y="-10205"/>
            <a:ext cx="343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A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BAEF79D-9806-E61E-48AB-79B7A37B064B}"/>
              </a:ext>
            </a:extLst>
          </p:cNvPr>
          <p:cNvSpPr txBox="1"/>
          <p:nvPr/>
        </p:nvSpPr>
        <p:spPr>
          <a:xfrm>
            <a:off x="3936910" y="-171"/>
            <a:ext cx="45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B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60382F5-4DE3-DB66-A643-E74C2597BD89}"/>
              </a:ext>
            </a:extLst>
          </p:cNvPr>
          <p:cNvSpPr txBox="1"/>
          <p:nvPr/>
        </p:nvSpPr>
        <p:spPr>
          <a:xfrm>
            <a:off x="7374928" y="61038"/>
            <a:ext cx="425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C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0AF99D7-DE0F-EB9E-EA34-02646CF3635B}"/>
              </a:ext>
            </a:extLst>
          </p:cNvPr>
          <p:cNvSpPr txBox="1"/>
          <p:nvPr/>
        </p:nvSpPr>
        <p:spPr>
          <a:xfrm>
            <a:off x="437054" y="2081080"/>
            <a:ext cx="343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D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5460103-24CA-A1B2-BF39-933E3E9BC84F}"/>
              </a:ext>
            </a:extLst>
          </p:cNvPr>
          <p:cNvSpPr txBox="1"/>
          <p:nvPr/>
        </p:nvSpPr>
        <p:spPr>
          <a:xfrm>
            <a:off x="3973753" y="2091114"/>
            <a:ext cx="45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E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83D0B02-572E-332F-0AD1-14C231836E54}"/>
              </a:ext>
            </a:extLst>
          </p:cNvPr>
          <p:cNvSpPr txBox="1"/>
          <p:nvPr/>
        </p:nvSpPr>
        <p:spPr>
          <a:xfrm>
            <a:off x="7411771" y="2095797"/>
            <a:ext cx="425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F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8D1F6BD-F8C7-4B6C-21A6-B78BA52A355D}"/>
              </a:ext>
            </a:extLst>
          </p:cNvPr>
          <p:cNvSpPr txBox="1"/>
          <p:nvPr/>
        </p:nvSpPr>
        <p:spPr>
          <a:xfrm>
            <a:off x="437054" y="4239845"/>
            <a:ext cx="343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G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EC79584-3AF9-0A2D-2426-95AD69C76BC5}"/>
              </a:ext>
            </a:extLst>
          </p:cNvPr>
          <p:cNvSpPr txBox="1"/>
          <p:nvPr/>
        </p:nvSpPr>
        <p:spPr>
          <a:xfrm>
            <a:off x="3973753" y="4249879"/>
            <a:ext cx="45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H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D21483F-449A-7FB5-E073-C72F8BA16A97}"/>
              </a:ext>
            </a:extLst>
          </p:cNvPr>
          <p:cNvSpPr txBox="1"/>
          <p:nvPr/>
        </p:nvSpPr>
        <p:spPr>
          <a:xfrm>
            <a:off x="7411771" y="4254562"/>
            <a:ext cx="425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Black" panose="020B0A04020102020204" pitchFamily="34" charset="0"/>
              </a:rPr>
              <a:t>I</a:t>
            </a:r>
            <a:endParaRPr lang="zh-CN" altLang="en-US" dirty="0">
              <a:latin typeface="Arial Black" panose="020B0A040201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57DDA22-65CE-2715-7393-0702C2305B6C}"/>
              </a:ext>
            </a:extLst>
          </p:cNvPr>
          <p:cNvSpPr txBox="1"/>
          <p:nvPr/>
        </p:nvSpPr>
        <p:spPr>
          <a:xfrm>
            <a:off x="227975" y="6067368"/>
            <a:ext cx="1137270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it-IT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S</a:t>
            </a:r>
            <a:r>
              <a:rPr kumimoji="0" lang="en-US" altLang="zh-CN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upplementary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 figure 1</a:t>
            </a:r>
            <a:r>
              <a:rPr kumimoji="0" lang="it-IT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(A)OPLS-DA score scatter plot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for group E1 and E2 ; (B) The permutation test with permutation number of 200 for the OPLS-DA model of group E1 and E2; (C) Volcano plot for group E1 and E2;</a:t>
            </a:r>
            <a:r>
              <a: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(D)OPLS-DA score scatter plot for group E1 and E3 ; (E) The permutation test with permutation number of 200 for the OPLS-DA model of group E1 and E3; (F) Volcano plot for group E1 and E3; (G)OPLS-DA score scatter plot for group E2 and E3 ; (H) The permutation test with permutation number of 200 for the OPLS-DA model of group E2 and E3; (I) Volcano plot for group E2 and E3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274027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49</Words>
  <Application>Microsoft Office PowerPoint</Application>
  <PresentationFormat>宽屏</PresentationFormat>
  <Paragraphs>1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微软雅黑</vt:lpstr>
      <vt:lpstr>Arial</vt:lpstr>
      <vt:lpstr>Arial Black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畅畅 葛</dc:creator>
  <cp:lastModifiedBy>畅畅 葛</cp:lastModifiedBy>
  <cp:revision>1</cp:revision>
  <dcterms:created xsi:type="dcterms:W3CDTF">2024-09-19T08:43:02Z</dcterms:created>
  <dcterms:modified xsi:type="dcterms:W3CDTF">2024-09-19T09:11:12Z</dcterms:modified>
</cp:coreProperties>
</file>